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71" r:id="rId2"/>
    <p:sldId id="272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49E882F5-072D-DF4F-92E7-EF0AD4F7E177}">
          <p14:sldIdLst>
            <p14:sldId id="271"/>
            <p14:sldId id="272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68B"/>
    <a:srgbClr val="FF24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69"/>
    <p:restoredTop sz="97674"/>
  </p:normalViewPr>
  <p:slideViewPr>
    <p:cSldViewPr snapToGrid="0">
      <p:cViewPr varScale="1">
        <p:scale>
          <a:sx n="85" d="100"/>
          <a:sy n="85" d="100"/>
        </p:scale>
        <p:origin x="3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6E5109-D852-D04E-B9E8-0C8B47B42F75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460014-EC34-1548-9FB8-4F8B94B69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375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lnSpc>
                <a:spcPct val="200000"/>
              </a:lnSpc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460014-EC34-1548-9FB8-4F8B94B69AE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953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3810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983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862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306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92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48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92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252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09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443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85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DC916-B914-A74A-B8E0-F1E1D387C76C}" type="datetimeFigureOut">
              <a:rPr lang="en-US" smtClean="0"/>
              <a:t>6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59CB8A-2FF8-EA4A-B943-E38ED318DF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076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6743D47-48EB-1A03-214D-6E839F24FA0B}"/>
              </a:ext>
            </a:extLst>
          </p:cNvPr>
          <p:cNvSpPr txBox="1"/>
          <p:nvPr/>
        </p:nvSpPr>
        <p:spPr>
          <a:xfrm>
            <a:off x="0" y="0"/>
            <a:ext cx="2385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S12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52AA6E6-D89C-883B-CF3C-666CCE252879}"/>
              </a:ext>
            </a:extLst>
          </p:cNvPr>
          <p:cNvGrpSpPr/>
          <p:nvPr/>
        </p:nvGrpSpPr>
        <p:grpSpPr>
          <a:xfrm>
            <a:off x="3864258" y="426623"/>
            <a:ext cx="2380986" cy="2342543"/>
            <a:chOff x="5158669" y="5589818"/>
            <a:chExt cx="2901798" cy="2854946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D7E4AEC7-AE2C-CF28-4757-1DA45FBED1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16095" b="4750"/>
            <a:stretch/>
          </p:blipFill>
          <p:spPr>
            <a:xfrm>
              <a:off x="5158669" y="5589818"/>
              <a:ext cx="2901798" cy="2854946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4C1B12D3-0806-DE01-F71D-2E328DE582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5085" t="32178" b="50800"/>
            <a:stretch/>
          </p:blipFill>
          <p:spPr>
            <a:xfrm>
              <a:off x="7462805" y="5898786"/>
              <a:ext cx="467360" cy="457200"/>
            </a:xfrm>
            <a:prstGeom prst="rect">
              <a:avLst/>
            </a:prstGeom>
          </p:spPr>
        </p:pic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48EA8191-FD01-4C5C-F908-B3749F2C09EF}"/>
              </a:ext>
            </a:extLst>
          </p:cNvPr>
          <p:cNvGrpSpPr/>
          <p:nvPr/>
        </p:nvGrpSpPr>
        <p:grpSpPr>
          <a:xfrm>
            <a:off x="3946006" y="3262535"/>
            <a:ext cx="2203273" cy="2203795"/>
            <a:chOff x="5515393" y="8821927"/>
            <a:chExt cx="2685213" cy="2685849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12295A93-C443-AFA3-6F91-AA7FE43B74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14306"/>
            <a:stretch/>
          </p:blipFill>
          <p:spPr>
            <a:xfrm>
              <a:off x="5515393" y="8821927"/>
              <a:ext cx="2685213" cy="2685849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2AD8AE77-1E2E-2EB1-C2E7-170C4FA828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85085" t="32178" b="50800"/>
            <a:stretch/>
          </p:blipFill>
          <p:spPr>
            <a:xfrm>
              <a:off x="7428447" y="9087873"/>
              <a:ext cx="467360" cy="457200"/>
            </a:xfrm>
            <a:prstGeom prst="rect">
              <a:avLst/>
            </a:prstGeom>
          </p:spPr>
        </p:pic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47635F81-1C1C-A70D-3FD3-38E77F941C31}"/>
              </a:ext>
            </a:extLst>
          </p:cNvPr>
          <p:cNvGrpSpPr/>
          <p:nvPr/>
        </p:nvGrpSpPr>
        <p:grpSpPr>
          <a:xfrm>
            <a:off x="309726" y="3412192"/>
            <a:ext cx="3015224" cy="2000940"/>
            <a:chOff x="178676" y="4198397"/>
            <a:chExt cx="3603029" cy="2391013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935C32EE-5386-BCCF-681F-ACD40CE282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r="20086"/>
            <a:stretch/>
          </p:blipFill>
          <p:spPr>
            <a:xfrm>
              <a:off x="656969" y="4632356"/>
              <a:ext cx="2907711" cy="1819278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A42EDB4C-8549-3870-6010-7A7D19CA08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80677" t="18862" b="50000"/>
            <a:stretch/>
          </p:blipFill>
          <p:spPr>
            <a:xfrm>
              <a:off x="3024026" y="4506536"/>
              <a:ext cx="757679" cy="610472"/>
            </a:xfrm>
            <a:prstGeom prst="rect">
              <a:avLst/>
            </a:prstGeom>
          </p:spPr>
        </p:pic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D55776E7-84B6-BF59-FB08-DB727FD099AF}"/>
                </a:ext>
              </a:extLst>
            </p:cNvPr>
            <p:cNvSpPr/>
            <p:nvPr/>
          </p:nvSpPr>
          <p:spPr>
            <a:xfrm>
              <a:off x="178676" y="4234960"/>
              <a:ext cx="363733" cy="230913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387B530-F918-7787-A4E0-A374D8F0E147}"/>
                </a:ext>
              </a:extLst>
            </p:cNvPr>
            <p:cNvSpPr txBox="1"/>
            <p:nvPr/>
          </p:nvSpPr>
          <p:spPr>
            <a:xfrm rot="16200000">
              <a:off x="-849807" y="5246793"/>
              <a:ext cx="2391013" cy="294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Krishna et al., Cancer Cell 2021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5522877F-470E-5BA6-FD58-873A85D700AE}"/>
              </a:ext>
            </a:extLst>
          </p:cNvPr>
          <p:cNvSpPr txBox="1"/>
          <p:nvPr/>
        </p:nvSpPr>
        <p:spPr>
          <a:xfrm>
            <a:off x="0" y="36791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E489922-3CB9-E546-EF42-E3BAEA71FB8C}"/>
              </a:ext>
            </a:extLst>
          </p:cNvPr>
          <p:cNvSpPr txBox="1"/>
          <p:nvPr/>
        </p:nvSpPr>
        <p:spPr>
          <a:xfrm>
            <a:off x="26" y="3387525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F69360B-845B-5FD5-5F2D-DD6674B9E9C1}"/>
              </a:ext>
            </a:extLst>
          </p:cNvPr>
          <p:cNvSpPr txBox="1"/>
          <p:nvPr/>
        </p:nvSpPr>
        <p:spPr>
          <a:xfrm>
            <a:off x="3527840" y="37035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297084F-C804-07BD-A372-F59D22DA3BE2}"/>
              </a:ext>
            </a:extLst>
          </p:cNvPr>
          <p:cNvSpPr txBox="1"/>
          <p:nvPr/>
        </p:nvSpPr>
        <p:spPr>
          <a:xfrm>
            <a:off x="3518222" y="3389723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E8D9C63D-6999-3B44-A23E-F87A5622582D}"/>
              </a:ext>
            </a:extLst>
          </p:cNvPr>
          <p:cNvGrpSpPr/>
          <p:nvPr/>
        </p:nvGrpSpPr>
        <p:grpSpPr>
          <a:xfrm>
            <a:off x="353129" y="467901"/>
            <a:ext cx="2373106" cy="2786298"/>
            <a:chOff x="317716" y="737245"/>
            <a:chExt cx="2835732" cy="3329474"/>
          </a:xfrm>
        </p:grpSpPr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452DC3F0-7C05-8DF9-941F-A1116C47B2A7}"/>
                </a:ext>
              </a:extLst>
            </p:cNvPr>
            <p:cNvSpPr/>
            <p:nvPr/>
          </p:nvSpPr>
          <p:spPr>
            <a:xfrm>
              <a:off x="317716" y="737245"/>
              <a:ext cx="363733" cy="3329474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n>
                  <a:solidFill>
                    <a:sysClr val="windowText" lastClr="000000"/>
                  </a:solidFill>
                </a:ln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FDA6211-D90F-9B1B-4A31-9475AED6875D}"/>
                </a:ext>
              </a:extLst>
            </p:cNvPr>
            <p:cNvSpPr txBox="1"/>
            <p:nvPr/>
          </p:nvSpPr>
          <p:spPr>
            <a:xfrm rot="16200000">
              <a:off x="-714553" y="1880492"/>
              <a:ext cx="2395392" cy="294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Zheng et al., Science 2021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0411BE05-EB90-89AF-DD87-C978953E60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1647"/>
            <a:stretch/>
          </p:blipFill>
          <p:spPr>
            <a:xfrm>
              <a:off x="896622" y="737245"/>
              <a:ext cx="2256826" cy="3329474"/>
            </a:xfrm>
            <a:prstGeom prst="rect">
              <a:avLst/>
            </a:prstGeom>
          </p:spPr>
        </p:pic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DE9D6845-0645-70A1-C7E2-8FE9E5B9753D}"/>
              </a:ext>
            </a:extLst>
          </p:cNvPr>
          <p:cNvSpPr txBox="1"/>
          <p:nvPr/>
        </p:nvSpPr>
        <p:spPr>
          <a:xfrm>
            <a:off x="12850" y="5733357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BE5BCAF-0C72-6819-B3A7-29D26471DA23}"/>
              </a:ext>
            </a:extLst>
          </p:cNvPr>
          <p:cNvSpPr txBox="1"/>
          <p:nvPr/>
        </p:nvSpPr>
        <p:spPr>
          <a:xfrm>
            <a:off x="25911" y="7217151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47C14C3-0B56-61ED-E42A-340601CB83DF}"/>
              </a:ext>
            </a:extLst>
          </p:cNvPr>
          <p:cNvSpPr txBox="1"/>
          <p:nvPr/>
        </p:nvSpPr>
        <p:spPr>
          <a:xfrm>
            <a:off x="2590015" y="725139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FA774222-8D3B-4BDC-1512-020E45F0FA5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3130" y="5733358"/>
            <a:ext cx="1903100" cy="1522480"/>
          </a:xfrm>
          <a:prstGeom prst="rect">
            <a:avLst/>
          </a:prstGeom>
          <a:ln>
            <a:noFill/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08FADE13-5F12-F28B-3E8D-A4542CCA263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690824" y="5733358"/>
            <a:ext cx="1903100" cy="1522480"/>
          </a:xfrm>
          <a:prstGeom prst="rect">
            <a:avLst/>
          </a:prstGeom>
          <a:ln>
            <a:noFill/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1CB4732C-6AC2-00B8-BC44-6C395F0B5E98}"/>
              </a:ext>
            </a:extLst>
          </p:cNvPr>
          <p:cNvSpPr txBox="1"/>
          <p:nvPr/>
        </p:nvSpPr>
        <p:spPr>
          <a:xfrm>
            <a:off x="4818967" y="7251396"/>
            <a:ext cx="328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8C81672C-F200-D2D6-9052-58EB6ACAB97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5701" y="7658750"/>
            <a:ext cx="2151529" cy="1434353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28E6AFC4-0180-A071-BC0F-5E0B676C23F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240449" y="7658750"/>
            <a:ext cx="2389953" cy="1433972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5BABCD3A-B5CC-8331-0C06-E151EA34911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693621" y="7658750"/>
            <a:ext cx="2151529" cy="1434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9864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F3A91F6-A4A1-49FF-F1B1-60839FB6F26A}"/>
              </a:ext>
            </a:extLst>
          </p:cNvPr>
          <p:cNvSpPr txBox="1"/>
          <p:nvPr/>
        </p:nvSpPr>
        <p:spPr>
          <a:xfrm>
            <a:off x="0" y="0"/>
            <a:ext cx="6858000" cy="3485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spcBef>
                <a:spcPts val="300"/>
              </a:spcBef>
            </a:pPr>
            <a:r>
              <a:rPr lang="en-US" sz="900" b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upplementary Figure 12. RCC associated TCR motifs</a:t>
            </a:r>
          </a:p>
          <a:p>
            <a:pPr lvl="0">
              <a:spcBef>
                <a:spcPts val="300"/>
              </a:spcBef>
            </a:pPr>
            <a:endParaRPr lang="en-US" sz="9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Validation of RCC-associated TCR motifs in the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cRNA+TCR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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seq data (Zheng et al</a:t>
            </a:r>
            <a:r>
              <a:rPr lang="en-US" sz="9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). From the Zheng et al</a:t>
            </a:r>
            <a:r>
              <a:rPr lang="en-US" sz="9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cohort, we selected samples with at least 100 TCR reads and were left with RCC samples (n=6) and samples from 15 different tumors (n=76). The p-value was calculated with the two-sided Wilcoxon matched-pairs signed rank test. The tumor sample abbreviations and sample numbers are be found in Supplementary Table S3.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Validation of RCC-associated TCR motifs in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cRNA+TCR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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seq data (Krishna et al</a:t>
            </a:r>
            <a:r>
              <a:rPr lang="en-US" sz="9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). The odds ratio for a pattern to have a certain phenotype was calculated, and the phenotype with the largest odds ratio was assumed to be the dominating phenotype.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 phenotype of RCC-associated TCR motifs in the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cRNA+TCR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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seq data (Zheng et al</a:t>
            </a:r>
            <a:r>
              <a:rPr lang="en-US" sz="9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2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). The odds ratio for a pattern to have a certain phenotype was calculated, and the phenotype with the largest odds ratio was assumed to be the dominating phenotype. 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 phenotype of RCC-associated TCR motifs in the </a:t>
            </a:r>
            <a:r>
              <a:rPr lang="en-US" sz="900" dirty="0" err="1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cRNA+TCR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  <a:sym typeface="Symbol" pitchFamily="2" charset="2"/>
              </a:rPr>
              <a:t>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seq data (Krishna et al</a:t>
            </a:r>
            <a:r>
              <a:rPr lang="en-US" sz="9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3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).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atients (n=6) were sampled multiple times, and each bar represents individual samples from one patient.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rom the TCGA data</a:t>
            </a:r>
            <a:r>
              <a:rPr lang="en-US" sz="9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4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the number of TCRs recovered from the bulk-RNA-seq was observed to be highly correlative with the number of predicted T-cells, as calculated by a cytotoxicity score (left panel, geometric mean of 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D8A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CD8B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ZMA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GZMB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, </a:t>
            </a:r>
            <a:r>
              <a:rPr lang="en-US" sz="900" i="1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RF1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 (Spearman correlation R=0.81, p&lt;2.2x10</a:t>
            </a:r>
            <a:r>
              <a:rPr lang="en-US" sz="9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6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. The number of TCRs correlated with the number of TCRs with RCC-associated motifs (right panel, Spearman correlation R=0.72, p&lt;2.2x10</a:t>
            </a:r>
            <a:r>
              <a:rPr lang="en-US" sz="900" baseline="30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-6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). 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In the TCGA cohort of patients with at least 100 recovered TCR reads from the bulk-RNA-seq data, the number of TCRs (and thus the number of T-cells) was associated with worse overall survival (OS) (p=0.033, log-rank test).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The number of TCRs with RCC-associated motifs was also associated with worse OS (p=0.021, log-rank test). 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 marL="342900" lvl="0" indent="-342900">
              <a:spcBef>
                <a:spcPts val="300"/>
              </a:spcBef>
              <a:buFont typeface="+mj-lt"/>
              <a:buAutoNum type="alphaUcPeriod"/>
            </a:pP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When the number of TCRs with RCC-associated motifs is normalized to the number of TCRs in total there is no association with OS (p=0.30, log-rank test), suggesting that RCC-associated motifs are associated with multiple (such as some with CD8+ T</a:t>
            </a:r>
            <a:r>
              <a:rPr lang="en-US" sz="9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XH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while others with T</a:t>
            </a:r>
            <a:r>
              <a:rPr lang="en-US" sz="900" baseline="-250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REG</a:t>
            </a:r>
            <a:r>
              <a:rPr lang="en-US" sz="9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phenotypes), and not just one phenotype. </a:t>
            </a:r>
            <a:endParaRPr lang="en-FI" sz="900" dirty="0">
              <a:effectLst/>
              <a:latin typeface="Calibri" panose="020F0502020204030204" pitchFamily="34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8550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86</TotalTime>
  <Words>472</Words>
  <Application>Microsoft Macintosh PowerPoint</Application>
  <PresentationFormat>A4-paperi (210 x 297 mm)</PresentationFormat>
  <Paragraphs>22</Paragraphs>
  <Slides>2</Slides>
  <Notes>1</Notes>
  <HiddenSlides>0</HiddenSlides>
  <MMClips>0</MMClips>
  <ScaleCrop>false</ScaleCrop>
  <HeadingPairs>
    <vt:vector size="6" baseType="variant">
      <vt:variant>
        <vt:lpstr>Käytetyt fontit</vt:lpstr>
      </vt:variant>
      <vt:variant>
        <vt:i4>4</vt:i4>
      </vt:variant>
      <vt:variant>
        <vt:lpstr>Teema</vt:lpstr>
      </vt:variant>
      <vt:variant>
        <vt:i4>1</vt:i4>
      </vt:variant>
      <vt:variant>
        <vt:lpstr>Dian otsikot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-esitys</vt:lpstr>
      <vt:lpstr>PowerPoint-esity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Moon Hee</dc:creator>
  <cp:lastModifiedBy>Mustjoki, Satu M</cp:lastModifiedBy>
  <cp:revision>395</cp:revision>
  <dcterms:created xsi:type="dcterms:W3CDTF">2022-10-13T13:05:53Z</dcterms:created>
  <dcterms:modified xsi:type="dcterms:W3CDTF">2023-06-17T07:35:30Z</dcterms:modified>
</cp:coreProperties>
</file>